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7" r:id="rId3"/>
    <p:sldId id="269" r:id="rId4"/>
    <p:sldId id="271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7" autoAdjust="0"/>
    <p:restoredTop sz="94660"/>
  </p:normalViewPr>
  <p:slideViewPr>
    <p:cSldViewPr>
      <p:cViewPr varScale="1">
        <p:scale>
          <a:sx n="113" d="100"/>
          <a:sy n="113" d="100"/>
        </p:scale>
        <p:origin x="1338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ashish\Documents\Projects\Hypoxia\annotate.hypoxia.GLMM\FDR_Geom&amp;ArithMean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ashish\Documents\Projects\Hypoxia\annotate.hypoxia.GLMM\FDR_Geom&amp;ArithMean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4"/>
    </mc:Choice>
    <mc:Fallback>
      <c:style val="34"/>
    </mc:Fallback>
  </mc:AlternateContent>
  <c:chart>
    <c:autoTitleDeleted val="0"/>
    <c:plotArea>
      <c:layout>
        <c:manualLayout>
          <c:layoutTarget val="inner"/>
          <c:xMode val="edge"/>
          <c:yMode val="edge"/>
          <c:x val="8.7618184800763541E-2"/>
          <c:y val="4.4894101228283023E-2"/>
          <c:w val="0.88547693967231356"/>
          <c:h val="0.744866541224892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enomicContextAnnotations!$Y$2</c:f>
              <c:strCache>
                <c:ptCount val="1"/>
                <c:pt idx="0">
                  <c:v>chr2L</c:v>
                </c:pt>
              </c:strCache>
            </c:strRef>
          </c:tx>
          <c:spPr>
            <a:ln>
              <a:noFill/>
            </a:ln>
          </c:spPr>
          <c:invertIfNegative val="0"/>
          <c:cat>
            <c:strRef>
              <c:f>GenomicContextAnnotations!$X$3:$X$7</c:f>
              <c:strCache>
                <c:ptCount val="5"/>
                <c:pt idx="0">
                  <c:v>intronic</c:v>
                </c:pt>
                <c:pt idx="1">
                  <c:v>intergenic</c:v>
                </c:pt>
                <c:pt idx="2">
                  <c:v>exonic</c:v>
                </c:pt>
                <c:pt idx="3">
                  <c:v>UTRs</c:v>
                </c:pt>
                <c:pt idx="4">
                  <c:v>ncRNA</c:v>
                </c:pt>
              </c:strCache>
            </c:strRef>
          </c:cat>
          <c:val>
            <c:numRef>
              <c:f>GenomicContextAnnotations!$Y$3:$Y$7</c:f>
              <c:numCache>
                <c:formatCode>General</c:formatCode>
                <c:ptCount val="5"/>
                <c:pt idx="0">
                  <c:v>118168</c:v>
                </c:pt>
                <c:pt idx="1">
                  <c:v>98303</c:v>
                </c:pt>
                <c:pt idx="2">
                  <c:v>34090</c:v>
                </c:pt>
                <c:pt idx="3">
                  <c:v>15355</c:v>
                </c:pt>
                <c:pt idx="4">
                  <c:v>1191</c:v>
                </c:pt>
              </c:numCache>
            </c:numRef>
          </c:val>
        </c:ser>
        <c:ser>
          <c:idx val="1"/>
          <c:order val="1"/>
          <c:tx>
            <c:strRef>
              <c:f>GenomicContextAnnotations!$Z$2</c:f>
              <c:strCache>
                <c:ptCount val="1"/>
                <c:pt idx="0">
                  <c:v>chr2R</c:v>
                </c:pt>
              </c:strCache>
            </c:strRef>
          </c:tx>
          <c:spPr>
            <a:solidFill>
              <a:srgbClr val="00CC00"/>
            </a:solidFill>
            <a:ln>
              <a:noFill/>
            </a:ln>
          </c:spPr>
          <c:invertIfNegative val="0"/>
          <c:cat>
            <c:strRef>
              <c:f>GenomicContextAnnotations!$X$3:$X$7</c:f>
              <c:strCache>
                <c:ptCount val="5"/>
                <c:pt idx="0">
                  <c:v>intronic</c:v>
                </c:pt>
                <c:pt idx="1">
                  <c:v>intergenic</c:v>
                </c:pt>
                <c:pt idx="2">
                  <c:v>exonic</c:v>
                </c:pt>
                <c:pt idx="3">
                  <c:v>UTRs</c:v>
                </c:pt>
                <c:pt idx="4">
                  <c:v>ncRNA</c:v>
                </c:pt>
              </c:strCache>
            </c:strRef>
          </c:cat>
          <c:val>
            <c:numRef>
              <c:f>GenomicContextAnnotations!$Z$3:$Z$7</c:f>
              <c:numCache>
                <c:formatCode>General</c:formatCode>
                <c:ptCount val="5"/>
                <c:pt idx="0">
                  <c:v>85438</c:v>
                </c:pt>
                <c:pt idx="1">
                  <c:v>64811</c:v>
                </c:pt>
                <c:pt idx="2">
                  <c:v>27570</c:v>
                </c:pt>
                <c:pt idx="3">
                  <c:v>12683</c:v>
                </c:pt>
                <c:pt idx="4">
                  <c:v>647</c:v>
                </c:pt>
              </c:numCache>
            </c:numRef>
          </c:val>
        </c:ser>
        <c:ser>
          <c:idx val="2"/>
          <c:order val="2"/>
          <c:tx>
            <c:strRef>
              <c:f>GenomicContextAnnotations!$AA$2</c:f>
              <c:strCache>
                <c:ptCount val="1"/>
                <c:pt idx="0">
                  <c:v>chr3L</c:v>
                </c:pt>
              </c:strCache>
            </c:strRef>
          </c:tx>
          <c:spPr>
            <a:solidFill>
              <a:srgbClr val="FF99FF"/>
            </a:solidFill>
            <a:ln>
              <a:noFill/>
            </a:ln>
          </c:spPr>
          <c:invertIfNegative val="0"/>
          <c:cat>
            <c:strRef>
              <c:f>GenomicContextAnnotations!$X$3:$X$7</c:f>
              <c:strCache>
                <c:ptCount val="5"/>
                <c:pt idx="0">
                  <c:v>intronic</c:v>
                </c:pt>
                <c:pt idx="1">
                  <c:v>intergenic</c:v>
                </c:pt>
                <c:pt idx="2">
                  <c:v>exonic</c:v>
                </c:pt>
                <c:pt idx="3">
                  <c:v>UTRs</c:v>
                </c:pt>
                <c:pt idx="4">
                  <c:v>ncRNA</c:v>
                </c:pt>
              </c:strCache>
            </c:strRef>
          </c:cat>
          <c:val>
            <c:numRef>
              <c:f>GenomicContextAnnotations!$AA$3:$AA$7</c:f>
              <c:numCache>
                <c:formatCode>General</c:formatCode>
                <c:ptCount val="5"/>
                <c:pt idx="0">
                  <c:v>106089</c:v>
                </c:pt>
                <c:pt idx="1">
                  <c:v>87876</c:v>
                </c:pt>
                <c:pt idx="2">
                  <c:v>29204</c:v>
                </c:pt>
                <c:pt idx="3">
                  <c:v>14522</c:v>
                </c:pt>
                <c:pt idx="4">
                  <c:v>696</c:v>
                </c:pt>
              </c:numCache>
            </c:numRef>
          </c:val>
        </c:ser>
        <c:ser>
          <c:idx val="3"/>
          <c:order val="3"/>
          <c:tx>
            <c:strRef>
              <c:f>GenomicContextAnnotations!$AB$2</c:f>
              <c:strCache>
                <c:ptCount val="1"/>
                <c:pt idx="0">
                  <c:v>chr3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cat>
            <c:strRef>
              <c:f>GenomicContextAnnotations!$X$3:$X$7</c:f>
              <c:strCache>
                <c:ptCount val="5"/>
                <c:pt idx="0">
                  <c:v>intronic</c:v>
                </c:pt>
                <c:pt idx="1">
                  <c:v>intergenic</c:v>
                </c:pt>
                <c:pt idx="2">
                  <c:v>exonic</c:v>
                </c:pt>
                <c:pt idx="3">
                  <c:v>UTRs</c:v>
                </c:pt>
                <c:pt idx="4">
                  <c:v>ncRNA</c:v>
                </c:pt>
              </c:strCache>
            </c:strRef>
          </c:cat>
          <c:val>
            <c:numRef>
              <c:f>GenomicContextAnnotations!$AB$3:$AB$7</c:f>
              <c:numCache>
                <c:formatCode>General</c:formatCode>
                <c:ptCount val="5"/>
                <c:pt idx="0">
                  <c:v>113428</c:v>
                </c:pt>
                <c:pt idx="1">
                  <c:v>81550</c:v>
                </c:pt>
                <c:pt idx="2">
                  <c:v>29677</c:v>
                </c:pt>
                <c:pt idx="3">
                  <c:v>15531</c:v>
                </c:pt>
                <c:pt idx="4">
                  <c:v>2704</c:v>
                </c:pt>
              </c:numCache>
            </c:numRef>
          </c:val>
        </c:ser>
        <c:ser>
          <c:idx val="4"/>
          <c:order val="4"/>
          <c:tx>
            <c:strRef>
              <c:f>GenomicContextAnnotations!$AC$2</c:f>
              <c:strCache>
                <c:ptCount val="1"/>
                <c:pt idx="0">
                  <c:v>chrX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</c:spPr>
          <c:invertIfNegative val="0"/>
          <c:cat>
            <c:strRef>
              <c:f>GenomicContextAnnotations!$X$3:$X$7</c:f>
              <c:strCache>
                <c:ptCount val="5"/>
                <c:pt idx="0">
                  <c:v>intronic</c:v>
                </c:pt>
                <c:pt idx="1">
                  <c:v>intergenic</c:v>
                </c:pt>
                <c:pt idx="2">
                  <c:v>exonic</c:v>
                </c:pt>
                <c:pt idx="3">
                  <c:v>UTRs</c:v>
                </c:pt>
                <c:pt idx="4">
                  <c:v>ncRNA</c:v>
                </c:pt>
              </c:strCache>
            </c:strRef>
          </c:cat>
          <c:val>
            <c:numRef>
              <c:f>GenomicContextAnnotations!$AC$3:$AC$7</c:f>
              <c:numCache>
                <c:formatCode>General</c:formatCode>
                <c:ptCount val="5"/>
                <c:pt idx="0">
                  <c:v>60973</c:v>
                </c:pt>
                <c:pt idx="1">
                  <c:v>38026</c:v>
                </c:pt>
                <c:pt idx="2">
                  <c:v>10466</c:v>
                </c:pt>
                <c:pt idx="3">
                  <c:v>7357</c:v>
                </c:pt>
                <c:pt idx="4">
                  <c:v>35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69259248"/>
        <c:axId val="1169258160"/>
      </c:barChart>
      <c:catAx>
        <c:axId val="11692592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1680000"/>
          <a:lstStyle/>
          <a:p>
            <a:pPr>
              <a:defRPr sz="1200"/>
            </a:pPr>
            <a:endParaRPr lang="en-US"/>
          </a:p>
        </c:txPr>
        <c:crossAx val="1169258160"/>
        <c:crosses val="autoZero"/>
        <c:auto val="1"/>
        <c:lblAlgn val="ctr"/>
        <c:lblOffset val="100"/>
        <c:noMultiLvlLbl val="0"/>
      </c:catAx>
      <c:valAx>
        <c:axId val="11692581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169259248"/>
        <c:crosses val="autoZero"/>
        <c:crossBetween val="between"/>
        <c:dispUnits>
          <c:builtInUnit val="tenThousands"/>
        </c:dispUnits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10849961226437604"/>
          <c:y val="2.1533404434822746E-2"/>
          <c:w val="0.8663826296954471"/>
          <c:h val="0.13057227363195914"/>
        </c:manualLayout>
      </c:layout>
      <c:overlay val="0"/>
    </c:legend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2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34"/>
    </mc:Choice>
    <mc:Fallback>
      <c:style val="34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83276337191754"/>
          <c:y val="4.4894101228283023E-2"/>
          <c:w val="0.85865777086381545"/>
          <c:h val="0.651028379760686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GenomicContextAnnotations!$B$22</c:f>
              <c:strCache>
                <c:ptCount val="1"/>
                <c:pt idx="0">
                  <c:v>chr2L</c:v>
                </c:pt>
              </c:strCache>
            </c:strRef>
          </c:tx>
          <c:spPr>
            <a:ln>
              <a:noFill/>
            </a:ln>
          </c:spPr>
          <c:invertIfNegative val="0"/>
          <c:cat>
            <c:strRef>
              <c:f>GenomicContextAnnotations!$A$23:$A$28</c:f>
              <c:strCache>
                <c:ptCount val="6"/>
                <c:pt idx="0">
                  <c:v>Synonymous</c:v>
                </c:pt>
                <c:pt idx="1">
                  <c:v>Nonsynonymous</c:v>
                </c:pt>
                <c:pt idx="2">
                  <c:v>Frameshift</c:v>
                </c:pt>
                <c:pt idx="3">
                  <c:v>Nonframeshift</c:v>
                </c:pt>
                <c:pt idx="4">
                  <c:v>Stopgain</c:v>
                </c:pt>
                <c:pt idx="5">
                  <c:v>Stoploss</c:v>
                </c:pt>
              </c:strCache>
            </c:strRef>
          </c:cat>
          <c:val>
            <c:numRef>
              <c:f>GenomicContextAnnotations!$B$23:$B$28</c:f>
              <c:numCache>
                <c:formatCode>General</c:formatCode>
                <c:ptCount val="6"/>
                <c:pt idx="0">
                  <c:v>23691</c:v>
                </c:pt>
                <c:pt idx="1">
                  <c:v>9870</c:v>
                </c:pt>
                <c:pt idx="2">
                  <c:v>159</c:v>
                </c:pt>
                <c:pt idx="3">
                  <c:v>25</c:v>
                </c:pt>
                <c:pt idx="4">
                  <c:v>73</c:v>
                </c:pt>
                <c:pt idx="5">
                  <c:v>16</c:v>
                </c:pt>
              </c:numCache>
            </c:numRef>
          </c:val>
        </c:ser>
        <c:ser>
          <c:idx val="1"/>
          <c:order val="1"/>
          <c:tx>
            <c:strRef>
              <c:f>GenomicContextAnnotations!$C$22</c:f>
              <c:strCache>
                <c:ptCount val="1"/>
                <c:pt idx="0">
                  <c:v>chr2R</c:v>
                </c:pt>
              </c:strCache>
            </c:strRef>
          </c:tx>
          <c:spPr>
            <a:solidFill>
              <a:srgbClr val="00CC00"/>
            </a:solidFill>
            <a:ln>
              <a:noFill/>
            </a:ln>
          </c:spPr>
          <c:invertIfNegative val="0"/>
          <c:cat>
            <c:strRef>
              <c:f>GenomicContextAnnotations!$A$23:$A$28</c:f>
              <c:strCache>
                <c:ptCount val="6"/>
                <c:pt idx="0">
                  <c:v>Synonymous</c:v>
                </c:pt>
                <c:pt idx="1">
                  <c:v>Nonsynonymous</c:v>
                </c:pt>
                <c:pt idx="2">
                  <c:v>Frameshift</c:v>
                </c:pt>
                <c:pt idx="3">
                  <c:v>Nonframeshift</c:v>
                </c:pt>
                <c:pt idx="4">
                  <c:v>Stopgain</c:v>
                </c:pt>
                <c:pt idx="5">
                  <c:v>Stoploss</c:v>
                </c:pt>
              </c:strCache>
            </c:strRef>
          </c:cat>
          <c:val>
            <c:numRef>
              <c:f>GenomicContextAnnotations!$C$23:$C$28</c:f>
              <c:numCache>
                <c:formatCode>General</c:formatCode>
                <c:ptCount val="6"/>
                <c:pt idx="0">
                  <c:v>19149</c:v>
                </c:pt>
                <c:pt idx="1">
                  <c:v>8013</c:v>
                </c:pt>
                <c:pt idx="2">
                  <c:v>110</c:v>
                </c:pt>
                <c:pt idx="3">
                  <c:v>29</c:v>
                </c:pt>
                <c:pt idx="4">
                  <c:v>49</c:v>
                </c:pt>
                <c:pt idx="5">
                  <c:v>16</c:v>
                </c:pt>
              </c:numCache>
            </c:numRef>
          </c:val>
        </c:ser>
        <c:ser>
          <c:idx val="2"/>
          <c:order val="2"/>
          <c:tx>
            <c:strRef>
              <c:f>GenomicContextAnnotations!$D$22</c:f>
              <c:strCache>
                <c:ptCount val="1"/>
                <c:pt idx="0">
                  <c:v>chr3L</c:v>
                </c:pt>
              </c:strCache>
            </c:strRef>
          </c:tx>
          <c:spPr>
            <a:solidFill>
              <a:srgbClr val="FF99FF"/>
            </a:solidFill>
            <a:ln>
              <a:noFill/>
            </a:ln>
          </c:spPr>
          <c:invertIfNegative val="0"/>
          <c:cat>
            <c:strRef>
              <c:f>GenomicContextAnnotations!$A$23:$A$28</c:f>
              <c:strCache>
                <c:ptCount val="6"/>
                <c:pt idx="0">
                  <c:v>Synonymous</c:v>
                </c:pt>
                <c:pt idx="1">
                  <c:v>Nonsynonymous</c:v>
                </c:pt>
                <c:pt idx="2">
                  <c:v>Frameshift</c:v>
                </c:pt>
                <c:pt idx="3">
                  <c:v>Nonframeshift</c:v>
                </c:pt>
                <c:pt idx="4">
                  <c:v>Stopgain</c:v>
                </c:pt>
                <c:pt idx="5">
                  <c:v>Stoploss</c:v>
                </c:pt>
              </c:strCache>
            </c:strRef>
          </c:cat>
          <c:val>
            <c:numRef>
              <c:f>GenomicContextAnnotations!$D$23:$D$28</c:f>
              <c:numCache>
                <c:formatCode>General</c:formatCode>
                <c:ptCount val="6"/>
                <c:pt idx="0">
                  <c:v>20120</c:v>
                </c:pt>
                <c:pt idx="1">
                  <c:v>8717</c:v>
                </c:pt>
                <c:pt idx="2">
                  <c:v>106</c:v>
                </c:pt>
                <c:pt idx="3">
                  <c:v>24</c:v>
                </c:pt>
                <c:pt idx="4">
                  <c:v>40</c:v>
                </c:pt>
                <c:pt idx="5">
                  <c:v>9</c:v>
                </c:pt>
              </c:numCache>
            </c:numRef>
          </c:val>
        </c:ser>
        <c:ser>
          <c:idx val="3"/>
          <c:order val="3"/>
          <c:tx>
            <c:strRef>
              <c:f>GenomicContextAnnotations!$E$22</c:f>
              <c:strCache>
                <c:ptCount val="1"/>
                <c:pt idx="0">
                  <c:v>chr3R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cat>
            <c:strRef>
              <c:f>GenomicContextAnnotations!$A$23:$A$28</c:f>
              <c:strCache>
                <c:ptCount val="6"/>
                <c:pt idx="0">
                  <c:v>Synonymous</c:v>
                </c:pt>
                <c:pt idx="1">
                  <c:v>Nonsynonymous</c:v>
                </c:pt>
                <c:pt idx="2">
                  <c:v>Frameshift</c:v>
                </c:pt>
                <c:pt idx="3">
                  <c:v>Nonframeshift</c:v>
                </c:pt>
                <c:pt idx="4">
                  <c:v>Stopgain</c:v>
                </c:pt>
                <c:pt idx="5">
                  <c:v>Stoploss</c:v>
                </c:pt>
              </c:strCache>
            </c:strRef>
          </c:cat>
          <c:val>
            <c:numRef>
              <c:f>GenomicContextAnnotations!$E$23:$E$28</c:f>
              <c:numCache>
                <c:formatCode>General</c:formatCode>
                <c:ptCount val="6"/>
                <c:pt idx="0">
                  <c:v>19378</c:v>
                </c:pt>
                <c:pt idx="1">
                  <c:v>9669</c:v>
                </c:pt>
                <c:pt idx="2">
                  <c:v>146</c:v>
                </c:pt>
                <c:pt idx="3">
                  <c:v>28</c:v>
                </c:pt>
                <c:pt idx="4">
                  <c:v>58</c:v>
                </c:pt>
                <c:pt idx="5">
                  <c:v>17</c:v>
                </c:pt>
              </c:numCache>
            </c:numRef>
          </c:val>
        </c:ser>
        <c:ser>
          <c:idx val="4"/>
          <c:order val="4"/>
          <c:tx>
            <c:strRef>
              <c:f>GenomicContextAnnotations!$F$22</c:f>
              <c:strCache>
                <c:ptCount val="1"/>
                <c:pt idx="0">
                  <c:v>chrX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</c:spPr>
          <c:invertIfNegative val="0"/>
          <c:cat>
            <c:strRef>
              <c:f>GenomicContextAnnotations!$A$23:$A$28</c:f>
              <c:strCache>
                <c:ptCount val="6"/>
                <c:pt idx="0">
                  <c:v>Synonymous</c:v>
                </c:pt>
                <c:pt idx="1">
                  <c:v>Nonsynonymous</c:v>
                </c:pt>
                <c:pt idx="2">
                  <c:v>Frameshift</c:v>
                </c:pt>
                <c:pt idx="3">
                  <c:v>Nonframeshift</c:v>
                </c:pt>
                <c:pt idx="4">
                  <c:v>Stopgain</c:v>
                </c:pt>
                <c:pt idx="5">
                  <c:v>Stoploss</c:v>
                </c:pt>
              </c:strCache>
            </c:strRef>
          </c:cat>
          <c:val>
            <c:numRef>
              <c:f>GenomicContextAnnotations!$F$23:$F$28</c:f>
              <c:numCache>
                <c:formatCode>General</c:formatCode>
                <c:ptCount val="6"/>
                <c:pt idx="0">
                  <c:v>7142</c:v>
                </c:pt>
                <c:pt idx="1">
                  <c:v>3117</c:v>
                </c:pt>
                <c:pt idx="2">
                  <c:v>54</c:v>
                </c:pt>
                <c:pt idx="3">
                  <c:v>21</c:v>
                </c:pt>
                <c:pt idx="4">
                  <c:v>22</c:v>
                </c:pt>
                <c:pt idx="5">
                  <c:v>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69261424"/>
        <c:axId val="1380956592"/>
      </c:barChart>
      <c:catAx>
        <c:axId val="11692614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>
            <a:noFill/>
          </a:ln>
        </c:spPr>
        <c:txPr>
          <a:bodyPr rot="-1320000"/>
          <a:lstStyle/>
          <a:p>
            <a:pPr>
              <a:defRPr/>
            </a:pPr>
            <a:endParaRPr lang="en-US"/>
          </a:p>
        </c:txPr>
        <c:crossAx val="1380956592"/>
        <c:crosses val="autoZero"/>
        <c:auto val="1"/>
        <c:lblAlgn val="ctr"/>
        <c:lblOffset val="100"/>
        <c:noMultiLvlLbl val="0"/>
      </c:catAx>
      <c:valAx>
        <c:axId val="138095659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169261424"/>
        <c:crosses val="autoZero"/>
        <c:crossBetween val="between"/>
        <c:dispUnits>
          <c:builtInUnit val="thousands"/>
          <c:dispUnitsLbl>
            <c:layout>
              <c:manualLayout>
                <c:xMode val="edge"/>
                <c:yMode val="edge"/>
                <c:x val="1.0739850155614485E-2"/>
                <c:y val="4.4894101228283023E-2"/>
              </c:manualLayout>
            </c:layout>
          </c:dispUnitsLbl>
        </c:dispUnits>
      </c:valAx>
      <c:spPr>
        <a:noFill/>
        <a:ln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9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866604-53FF-410D-BEB1-EB67162CDA9E}" type="datetimeFigureOut">
              <a:rPr lang="en-US" smtClean="0"/>
              <a:t>7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E765BA-920E-4055-857B-A516A75F8236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4"/>
          <p:cNvSpPr txBox="1">
            <a:spLocks/>
          </p:cNvSpPr>
          <p:nvPr/>
        </p:nvSpPr>
        <p:spPr>
          <a:xfrm>
            <a:off x="463613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. Genome-wide distribution of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riants</a:t>
            </a:r>
            <a:endParaRPr 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243506" y="2054096"/>
            <a:ext cx="4238401" cy="2779510"/>
            <a:chOff x="522391" y="566395"/>
            <a:chExt cx="8046720" cy="5276964"/>
          </a:xfrm>
        </p:grpSpPr>
        <p:graphicFrame>
          <p:nvGraphicFramePr>
            <p:cNvPr id="6" name="Chart 5"/>
            <p:cNvGraphicFramePr>
              <a:graphicFrameLocks noChangeAspect="1"/>
            </p:cNvGraphicFramePr>
            <p:nvPr>
              <p:extLst/>
            </p:nvPr>
          </p:nvGraphicFramePr>
          <p:xfrm>
            <a:off x="522391" y="566395"/>
            <a:ext cx="8046720" cy="527696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Chart 6"/>
            <p:cNvGraphicFramePr>
              <a:graphicFrameLocks noChangeAspect="1"/>
            </p:cNvGraphicFramePr>
            <p:nvPr>
              <p:extLst/>
            </p:nvPr>
          </p:nvGraphicFramePr>
          <p:xfrm>
            <a:off x="3882468" y="1367918"/>
            <a:ext cx="4498595" cy="22867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10" name="Group 9"/>
          <p:cNvGrpSpPr/>
          <p:nvPr/>
        </p:nvGrpSpPr>
        <p:grpSpPr>
          <a:xfrm>
            <a:off x="4719744" y="1644686"/>
            <a:ext cx="4342332" cy="3116953"/>
            <a:chOff x="747779" y="250739"/>
            <a:chExt cx="8303971" cy="5960640"/>
          </a:xfrm>
        </p:grpSpPr>
        <p:sp>
          <p:nvSpPr>
            <p:cNvPr id="11" name="Oval 10"/>
            <p:cNvSpPr/>
            <p:nvPr/>
          </p:nvSpPr>
          <p:spPr>
            <a:xfrm>
              <a:off x="4727525" y="1011416"/>
              <a:ext cx="3882207" cy="4961928"/>
            </a:xfrm>
            <a:prstGeom prst="ellipse">
              <a:avLst/>
            </a:prstGeom>
            <a:solidFill>
              <a:schemeClr val="accent4">
                <a:lumMod val="75000"/>
              </a:schemeClr>
            </a:solidFill>
            <a:ln w="57150">
              <a:solidFill>
                <a:schemeClr val="accent4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endParaRPr lang="en-US" sz="1200" b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Oval 11"/>
            <p:cNvSpPr/>
            <p:nvPr/>
          </p:nvSpPr>
          <p:spPr>
            <a:xfrm>
              <a:off x="6424771" y="2264823"/>
              <a:ext cx="2126434" cy="2490543"/>
            </a:xfrm>
            <a:prstGeom prst="ellipse">
              <a:avLst/>
            </a:prstGeom>
            <a:solidFill>
              <a:schemeClr val="accent6">
                <a:lumMod val="50000"/>
              </a:schemeClr>
            </a:solidFill>
            <a:ln w="57150">
              <a:solidFill>
                <a:schemeClr val="accent6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Oval 13"/>
            <p:cNvSpPr/>
            <p:nvPr/>
          </p:nvSpPr>
          <p:spPr>
            <a:xfrm>
              <a:off x="747779" y="923762"/>
              <a:ext cx="7393744" cy="5287617"/>
            </a:xfrm>
            <a:prstGeom prst="ellipse">
              <a:avLst/>
            </a:prstGeom>
            <a:solidFill>
              <a:srgbClr val="FFC000"/>
            </a:solidFill>
            <a:ln w="571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US" sz="1200" b="1" dirty="0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190555" y="2881195"/>
              <a:ext cx="2387606" cy="9138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GRP variants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~5X10</a:t>
              </a:r>
              <a:r>
                <a:rPr lang="en-US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7061656" y="250739"/>
              <a:ext cx="1990094" cy="9138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 variants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~1.1X10</a:t>
              </a:r>
              <a:r>
                <a:rPr lang="en-US" sz="12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483296" y="1021857"/>
              <a:ext cx="971568" cy="5482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%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082384" y="1446907"/>
              <a:ext cx="971568" cy="5482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82%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122463" y="2491495"/>
              <a:ext cx="1696372" cy="12793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ivergent variants</a:t>
              </a:r>
            </a:p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~4K)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374794" y="3317230"/>
              <a:ext cx="971569" cy="548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%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Oval 20"/>
            <p:cNvSpPr/>
            <p:nvPr/>
          </p:nvSpPr>
          <p:spPr>
            <a:xfrm>
              <a:off x="4727525" y="1000396"/>
              <a:ext cx="3882207" cy="4961928"/>
            </a:xfrm>
            <a:prstGeom prst="ellipse">
              <a:avLst/>
            </a:prstGeom>
            <a:noFill/>
            <a:ln w="57150">
              <a:solidFill>
                <a:schemeClr val="accent4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r"/>
              <a:endParaRPr lang="en-US" sz="1200" b="1">
                <a:solidFill>
                  <a:sysClr val="windowText" lastClr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Oval 21"/>
            <p:cNvSpPr/>
            <p:nvPr/>
          </p:nvSpPr>
          <p:spPr>
            <a:xfrm>
              <a:off x="6454033" y="2274685"/>
              <a:ext cx="2126434" cy="2490543"/>
            </a:xfrm>
            <a:prstGeom prst="ellipse">
              <a:avLst/>
            </a:prstGeom>
            <a:noFill/>
            <a:ln w="57150">
              <a:solidFill>
                <a:schemeClr val="accent6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endParaRPr lang="en-US" sz="120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8051078" y="3153379"/>
              <a:ext cx="803398" cy="5482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  <a:endParaRPr lang="en-US" sz="12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38200" y="16446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105400" y="164468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1781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4"/>
          <p:cNvSpPr txBox="1">
            <a:spLocks/>
          </p:cNvSpPr>
          <p:nvPr/>
        </p:nvSpPr>
        <p:spPr>
          <a:xfrm>
            <a:off x="4572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.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Cumulative distribution of GLMM P-values.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0" y="1295400"/>
            <a:ext cx="4552006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592580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4"/>
          <p:cNvSpPr txBox="1">
            <a:spLocks/>
          </p:cNvSpPr>
          <p:nvPr/>
        </p:nvSpPr>
        <p:spPr>
          <a:xfrm>
            <a:off x="4572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.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Genome-wide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ans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in various window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zes to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identify long-range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inkage in the AFs</a:t>
            </a:r>
            <a:endParaRPr 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004627"/>
            <a:ext cx="9144000" cy="28487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02390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4"/>
          <p:cNvSpPr txBox="1">
            <a:spLocks/>
          </p:cNvSpPr>
          <p:nvPr/>
        </p:nvSpPr>
        <p:spPr>
          <a:xfrm>
            <a:off x="457200" y="0"/>
            <a:ext cx="8229600" cy="7281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. </a:t>
            </a:r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A flowchart of data </a:t>
            </a:r>
            <a:r>
              <a:rPr lang="en-US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nalysis.</a:t>
            </a:r>
            <a:endParaRPr 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2200" y="990600"/>
            <a:ext cx="4074175" cy="5669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87018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806</TotalTime>
  <Words>70</Words>
  <Application>Microsoft Office PowerPoint</Application>
  <PresentationFormat>On-screen Show (4:3)</PresentationFormat>
  <Paragraphs>16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nDell</dc:creator>
  <cp:lastModifiedBy>aashish</cp:lastModifiedBy>
  <cp:revision>52</cp:revision>
  <dcterms:created xsi:type="dcterms:W3CDTF">2014-04-14T01:15:48Z</dcterms:created>
  <dcterms:modified xsi:type="dcterms:W3CDTF">2015-07-06T15:29:46Z</dcterms:modified>
</cp:coreProperties>
</file>